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  <p:sldId id="257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685"/>
    <p:restoredTop sz="94691"/>
  </p:normalViewPr>
  <p:slideViewPr>
    <p:cSldViewPr snapToGrid="0" snapToObjects="1">
      <p:cViewPr varScale="1">
        <p:scale>
          <a:sx n="163" d="100"/>
          <a:sy n="163" d="100"/>
        </p:scale>
        <p:origin x="208" y="5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2255C1-7E1E-4E46-ABDE-C3B9B9DA71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A83B3A1-5AC6-5245-A324-FE24CF7B34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7CB864-81BD-D94B-9E83-71C92243A5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2B9B8-BB08-FE40-9933-5546486E2621}" type="datetimeFigureOut">
              <a:rPr lang="en-US" smtClean="0"/>
              <a:t>10/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296377-6A5D-1B4C-94CF-BEA6DC4F0B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02D639-B995-1640-BBE9-8715240AC2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AE0F3-9E31-EA44-A3B9-A06A46A2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625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3892DA-92B7-EC42-92C0-3D3706E076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41797C1-29BD-6843-AA13-B7447093CD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BBCDEB-10DC-014F-AC94-635781D685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2B9B8-BB08-FE40-9933-5546486E2621}" type="datetimeFigureOut">
              <a:rPr lang="en-US" smtClean="0"/>
              <a:t>10/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ED5B8C-FC6E-C341-82F1-CA040E259D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97543F-A059-4741-9366-880EECE591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AE0F3-9E31-EA44-A3B9-A06A46A2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5137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70B6FEB-280D-0E48-9965-8D95A5A0EB7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9BCC3E8-2D1F-E445-8C41-48BCD97907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231499-97EB-3745-984C-0A092A30C3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2B9B8-BB08-FE40-9933-5546486E2621}" type="datetimeFigureOut">
              <a:rPr lang="en-US" smtClean="0"/>
              <a:t>10/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D8CED9-997E-404F-811D-4DB4A48D26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0DB5FF-45C7-304B-A9E4-0F2A4E971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AE0F3-9E31-EA44-A3B9-A06A46A2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10628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2D686B-DAB5-6B44-B1D9-DF5BCA8D92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7E26DD-1A3B-8249-86BF-EE5B403A592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202155-E0DA-2346-AD01-48C2C31113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2B9B8-BB08-FE40-9933-5546486E2621}" type="datetimeFigureOut">
              <a:rPr lang="en-US" smtClean="0"/>
              <a:t>10/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B67AC1-DCA9-BC46-A36F-006EA11857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AB7424-1512-2A4C-8388-A13736067B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AE0F3-9E31-EA44-A3B9-A06A46A2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719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E8A659-AF06-014C-9317-3BC63DBA0F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02761B-9DB6-8143-AD6C-E46F0F0C1F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9AF30A-D5C9-A644-952B-D6AB97D7D2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2B9B8-BB08-FE40-9933-5546486E2621}" type="datetimeFigureOut">
              <a:rPr lang="en-US" smtClean="0"/>
              <a:t>10/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10653A-DA84-1D49-AF92-D0296D78B2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EF0767-6C45-AB46-AE6F-4B5922E39F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AE0F3-9E31-EA44-A3B9-A06A46A2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750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AC6356-64E0-1E44-88BA-AA52D8A7D8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386F63-FAD5-D44B-9950-05C620343A7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867324A-42D9-984C-AF4A-A22BC1032A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429CC1-06D1-184F-B0C9-4B31F3DDE0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2B9B8-BB08-FE40-9933-5546486E2621}" type="datetimeFigureOut">
              <a:rPr lang="en-US" smtClean="0"/>
              <a:t>10/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EF1C39-167F-CA4E-9186-7804DA388D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5A7D93-2FDD-314D-B052-B37852F2CC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AE0F3-9E31-EA44-A3B9-A06A46A2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94392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6B8F29-0659-024A-916A-BC6DD9ABB9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BFEF86-41F2-BF4F-A2C8-2F0987F522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4BAF6F-4FCA-3748-9042-631ED918DC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A71C798-6690-374D-9B95-39452F4DDB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84FF9FD-7AD3-BA47-9030-D27B2282F7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2F30C75-4BEA-664F-9450-401E324F1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2B9B8-BB08-FE40-9933-5546486E2621}" type="datetimeFigureOut">
              <a:rPr lang="en-US" smtClean="0"/>
              <a:t>10/7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E147A34-B3E4-2544-B685-E3642CBB23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2F9CB6E-6483-4840-8322-DB7A06BAF4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AE0F3-9E31-EA44-A3B9-A06A46A2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0318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CA04E0-7834-B448-B614-D243CDD2EB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57B206D-224B-754B-8EF6-D9A8291872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2B9B8-BB08-FE40-9933-5546486E2621}" type="datetimeFigureOut">
              <a:rPr lang="en-US" smtClean="0"/>
              <a:t>10/7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95EA93-4E7A-0E41-8DB9-9D827B29F0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B3A4D11-4D56-194D-B760-AA7204ABA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AE0F3-9E31-EA44-A3B9-A06A46A2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8308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6E19113-61C8-CD41-A5AC-8F59510D4E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2B9B8-BB08-FE40-9933-5546486E2621}" type="datetimeFigureOut">
              <a:rPr lang="en-US" smtClean="0"/>
              <a:t>10/7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86F797D-ED87-C945-A7CF-7099F7B283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5D94BA1-E57B-F946-A474-035384C24E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AE0F3-9E31-EA44-A3B9-A06A46A2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3679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52CE70-6CA0-ED46-A717-CB8C558F28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500C81-8288-3B4B-B19E-B6431466560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B033FD5-D45D-9041-9972-BE9EE33B11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CE71AB-D478-554B-85B1-88FCFAD0AB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2B9B8-BB08-FE40-9933-5546486E2621}" type="datetimeFigureOut">
              <a:rPr lang="en-US" smtClean="0"/>
              <a:t>10/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D9F593-7D22-704F-8B81-E733D9263C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6E52A3-654D-724B-AD60-2E2061E35C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AE0F3-9E31-EA44-A3B9-A06A46A2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20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3D77FC-A7E0-EB44-8031-E18CC6D06C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0F1725C-9333-5D4D-A16F-AF7C0CF67B2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58114EF-DFED-2648-9047-57A3F4DC51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E6B2B9-AF0B-D241-9BBF-B8D3CC2371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2B9B8-BB08-FE40-9933-5546486E2621}" type="datetimeFigureOut">
              <a:rPr lang="en-US" smtClean="0"/>
              <a:t>10/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1CCBFD-3944-504D-8C04-687D41ED48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5F461D-46AA-E848-AEBD-EABF1E5D74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AE0F3-9E31-EA44-A3B9-A06A46A2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908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38E5CB5-38FB-804C-AE31-C34E0D5790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494FF7-A9A6-6D4D-85D6-79B4B68170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AB1DA8-08CA-774B-B147-040426C551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72B9B8-BB08-FE40-9933-5546486E2621}" type="datetimeFigureOut">
              <a:rPr lang="en-US" smtClean="0"/>
              <a:t>10/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B36083-E629-E54A-8546-94E48ED395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59DE7B-3ED7-844F-84B4-DDE8C961E74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7AE0F3-9E31-EA44-A3B9-A06A46A2F5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64148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DA0FFEDE-3C54-044B-9AC6-EA9FF5776E9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27237" y="137786"/>
            <a:ext cx="6337526" cy="612522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8FCC3F4-E430-CC4D-B4CE-CC0B52A5B02A}"/>
              </a:ext>
            </a:extLst>
          </p:cNvPr>
          <p:cNvSpPr txBox="1"/>
          <p:nvPr/>
        </p:nvSpPr>
        <p:spPr>
          <a:xfrm>
            <a:off x="3183098" y="6350882"/>
            <a:ext cx="6081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ure S1 </a:t>
            </a:r>
            <a:r>
              <a:rPr lang="en-US" dirty="0"/>
              <a:t>Proportion and pattern of missing data</a:t>
            </a:r>
          </a:p>
        </p:txBody>
      </p:sp>
    </p:spTree>
    <p:extLst>
      <p:ext uri="{BB962C8B-B14F-4D97-AF65-F5344CB8AC3E}">
        <p14:creationId xmlns:p14="http://schemas.microsoft.com/office/powerpoint/2010/main" val="3159178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108ECCD-F3A4-0549-8309-9E5FDD0492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1878" y="1717667"/>
            <a:ext cx="5699808" cy="3685478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33259AB-F163-4D4F-AA53-8E07630879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86723" y="1717667"/>
            <a:ext cx="5692126" cy="368547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AD72DCF-F57F-5043-87ED-7176276E30A4}"/>
              </a:ext>
            </a:extLst>
          </p:cNvPr>
          <p:cNvSpPr txBox="1"/>
          <p:nvPr/>
        </p:nvSpPr>
        <p:spPr>
          <a:xfrm>
            <a:off x="141970" y="1257902"/>
            <a:ext cx="4700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b="1"/>
            </a:lvl1pPr>
          </a:lstStyle>
          <a:p>
            <a:r>
              <a:rPr lang="en-US" sz="1400" dirty="0"/>
              <a:t>S2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1C1C614-EC51-2D47-A1A0-E8D02C37AC7D}"/>
              </a:ext>
            </a:extLst>
          </p:cNvPr>
          <p:cNvSpPr txBox="1"/>
          <p:nvPr/>
        </p:nvSpPr>
        <p:spPr>
          <a:xfrm>
            <a:off x="6211252" y="1257902"/>
            <a:ext cx="4619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b="1"/>
            </a:lvl1pPr>
          </a:lstStyle>
          <a:p>
            <a:r>
              <a:rPr lang="en-US" sz="1400" dirty="0"/>
              <a:t>S2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993C028-EDE4-0542-8A7C-C9E3A30FA834}"/>
              </a:ext>
            </a:extLst>
          </p:cNvPr>
          <p:cNvSpPr txBox="1"/>
          <p:nvPr/>
        </p:nvSpPr>
        <p:spPr>
          <a:xfrm>
            <a:off x="1989134" y="5874893"/>
            <a:ext cx="8984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ure S2 Incidence of hepatotoxicity secondary from anti-PD-1 vs. anti-PD-L1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059749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3A23DD3-C7B8-4F41-9838-999DE0C794D2}"/>
              </a:ext>
            </a:extLst>
          </p:cNvPr>
          <p:cNvSpPr txBox="1"/>
          <p:nvPr/>
        </p:nvSpPr>
        <p:spPr>
          <a:xfrm>
            <a:off x="871969" y="6266142"/>
            <a:ext cx="102402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ure S3 Incidence of all-grade hepatotoxicity in primary live cancers vs. other cancer types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4991C36-B649-024B-BA8A-8D523D199A01}"/>
              </a:ext>
            </a:extLst>
          </p:cNvPr>
          <p:cNvSpPr txBox="1"/>
          <p:nvPr/>
        </p:nvSpPr>
        <p:spPr>
          <a:xfrm>
            <a:off x="151475" y="509456"/>
            <a:ext cx="4700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3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01AD606-35E3-D542-8F59-59CC9386229E}"/>
              </a:ext>
            </a:extLst>
          </p:cNvPr>
          <p:cNvSpPr txBox="1"/>
          <p:nvPr/>
        </p:nvSpPr>
        <p:spPr>
          <a:xfrm>
            <a:off x="3088749" y="509456"/>
            <a:ext cx="4619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3B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533F1E9-C362-3C45-BEE0-2B8D7AD5AF6E}"/>
              </a:ext>
            </a:extLst>
          </p:cNvPr>
          <p:cNvSpPr txBox="1"/>
          <p:nvPr/>
        </p:nvSpPr>
        <p:spPr>
          <a:xfrm>
            <a:off x="5987143" y="522216"/>
            <a:ext cx="4555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3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9775D8F-6324-7D40-902A-8D2495490591}"/>
              </a:ext>
            </a:extLst>
          </p:cNvPr>
          <p:cNvSpPr txBox="1"/>
          <p:nvPr/>
        </p:nvSpPr>
        <p:spPr>
          <a:xfrm>
            <a:off x="8916258" y="522216"/>
            <a:ext cx="4748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3D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0771E06-A116-024F-91F1-7B6F0B47301B}"/>
              </a:ext>
            </a:extLst>
          </p:cNvPr>
          <p:cNvSpPr txBox="1"/>
          <p:nvPr/>
        </p:nvSpPr>
        <p:spPr>
          <a:xfrm>
            <a:off x="151475" y="3323614"/>
            <a:ext cx="4491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3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0FF7F91-B894-2B40-9544-44DFDB5867B6}"/>
              </a:ext>
            </a:extLst>
          </p:cNvPr>
          <p:cNvSpPr txBox="1"/>
          <p:nvPr/>
        </p:nvSpPr>
        <p:spPr>
          <a:xfrm>
            <a:off x="3114754" y="3323614"/>
            <a:ext cx="4427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3F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2C8CA0E-4FC1-8345-918D-D201C7D34199}"/>
              </a:ext>
            </a:extLst>
          </p:cNvPr>
          <p:cNvSpPr txBox="1"/>
          <p:nvPr/>
        </p:nvSpPr>
        <p:spPr>
          <a:xfrm>
            <a:off x="5987143" y="3323614"/>
            <a:ext cx="4748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3G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D26E7A7-A7B7-4F44-8D18-F2706FF2BCE9}"/>
              </a:ext>
            </a:extLst>
          </p:cNvPr>
          <p:cNvSpPr txBox="1"/>
          <p:nvPr/>
        </p:nvSpPr>
        <p:spPr>
          <a:xfrm>
            <a:off x="1328897" y="818178"/>
            <a:ext cx="4440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LT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7C0CC67-8E4A-014C-BC01-B14FCBDD9D5E}"/>
              </a:ext>
            </a:extLst>
          </p:cNvPr>
          <p:cNvSpPr txBox="1"/>
          <p:nvPr/>
        </p:nvSpPr>
        <p:spPr>
          <a:xfrm>
            <a:off x="4182963" y="818178"/>
            <a:ext cx="4650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ST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4C9271E-0B80-EE40-8A8D-F63CA1C4A71E}"/>
              </a:ext>
            </a:extLst>
          </p:cNvPr>
          <p:cNvSpPr txBox="1"/>
          <p:nvPr/>
        </p:nvSpPr>
        <p:spPr>
          <a:xfrm>
            <a:off x="6900783" y="818178"/>
            <a:ext cx="8178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ilirubin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2137429-02AC-8648-8EF5-8F0757007AC2}"/>
              </a:ext>
            </a:extLst>
          </p:cNvPr>
          <p:cNvSpPr txBox="1"/>
          <p:nvPr/>
        </p:nvSpPr>
        <p:spPr>
          <a:xfrm>
            <a:off x="9930606" y="818178"/>
            <a:ext cx="4651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LP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044F03A-8113-9C4C-87FC-6AB33CFA656E}"/>
              </a:ext>
            </a:extLst>
          </p:cNvPr>
          <p:cNvSpPr txBox="1"/>
          <p:nvPr/>
        </p:nvSpPr>
        <p:spPr>
          <a:xfrm>
            <a:off x="1185583" y="3627652"/>
            <a:ext cx="4995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GGT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BE2C5DE-64A3-994F-BE5F-F0449C8F560E}"/>
              </a:ext>
            </a:extLst>
          </p:cNvPr>
          <p:cNvSpPr txBox="1"/>
          <p:nvPr/>
        </p:nvSpPr>
        <p:spPr>
          <a:xfrm>
            <a:off x="3682096" y="3627652"/>
            <a:ext cx="18582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Hepatobiliary disorder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798409D-82C9-5B47-89E8-2266E8CD1564}"/>
              </a:ext>
            </a:extLst>
          </p:cNvPr>
          <p:cNvSpPr txBox="1"/>
          <p:nvPr/>
        </p:nvSpPr>
        <p:spPr>
          <a:xfrm>
            <a:off x="6808001" y="3627652"/>
            <a:ext cx="10034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/>
              <a:t>Ir</a:t>
            </a:r>
            <a:r>
              <a:rPr lang="en-US" sz="1400" b="1" dirty="0"/>
              <a:t>-hepatitis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97595DE7-844B-DB42-91F6-C59284A8DFF8}"/>
              </a:ext>
            </a:extLst>
          </p:cNvPr>
          <p:cNvGrpSpPr/>
          <p:nvPr/>
        </p:nvGrpSpPr>
        <p:grpSpPr>
          <a:xfrm>
            <a:off x="167105" y="1068029"/>
            <a:ext cx="11576567" cy="4994448"/>
            <a:chOff x="167105" y="1068029"/>
            <a:chExt cx="11576567" cy="4994448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24C6207B-8998-764A-A5E9-B1775B1AF79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4722" y="1317700"/>
              <a:ext cx="2717911" cy="1862211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61795152-70D9-DD40-B1CF-0AAC3C5A70E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152652" y="1317700"/>
              <a:ext cx="2685818" cy="1862211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375F10A9-77AC-2F42-89FD-C6E45C7028D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038321" y="1329026"/>
              <a:ext cx="2699995" cy="1839557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94420AFE-B077-1248-885B-406AB615C05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918503" y="1338636"/>
              <a:ext cx="2711959" cy="1839557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32627259-A719-6349-A7C9-8F60A04DD3D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44722" y="4177528"/>
              <a:ext cx="2717911" cy="1884949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E1656D82-9E5B-8F4C-A327-8460BCF86CD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152652" y="4178171"/>
              <a:ext cx="2728074" cy="1884306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340B9FFB-8589-E64A-A051-91443EC2859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080577" y="4170485"/>
              <a:ext cx="2699996" cy="1891992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10857D0F-BBF7-F342-9399-2E5F60318B8C}"/>
                </a:ext>
              </a:extLst>
            </p:cNvPr>
            <p:cNvSpPr txBox="1"/>
            <p:nvPr/>
          </p:nvSpPr>
          <p:spPr>
            <a:xfrm>
              <a:off x="268491" y="1071479"/>
              <a:ext cx="27991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Type of Cancer                                                       Incidence (95% CI)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8C01B00-EC3F-1247-8B41-61C6EFFD9B26}"/>
                </a:ext>
              </a:extLst>
            </p:cNvPr>
            <p:cNvSpPr txBox="1"/>
            <p:nvPr/>
          </p:nvSpPr>
          <p:spPr>
            <a:xfrm>
              <a:off x="3191980" y="1071479"/>
              <a:ext cx="27991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Type of Cancer                                                       Incidence (95% CI)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2984DC1-2875-E24C-BB31-57AD3F79342B}"/>
                </a:ext>
              </a:extLst>
            </p:cNvPr>
            <p:cNvSpPr txBox="1"/>
            <p:nvPr/>
          </p:nvSpPr>
          <p:spPr>
            <a:xfrm>
              <a:off x="6070179" y="1068029"/>
              <a:ext cx="27991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Type of Cancer                                                       Incidence (95% CI)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F2FB634B-3FC6-514E-8843-9F0EB6FE5288}"/>
                </a:ext>
              </a:extLst>
            </p:cNvPr>
            <p:cNvSpPr txBox="1"/>
            <p:nvPr/>
          </p:nvSpPr>
          <p:spPr>
            <a:xfrm>
              <a:off x="8944508" y="1068029"/>
              <a:ext cx="27991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Type of Cancer                                                       Incidence (95% CI)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48705E8-9B75-5B4D-B120-F255863E1C93}"/>
                </a:ext>
              </a:extLst>
            </p:cNvPr>
            <p:cNvSpPr txBox="1"/>
            <p:nvPr/>
          </p:nvSpPr>
          <p:spPr>
            <a:xfrm>
              <a:off x="268491" y="3930582"/>
              <a:ext cx="27991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Type of Cancer                                                       Incidence (95% CI)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8867845-B0D9-6648-96E6-EEDB4468BCFB}"/>
                </a:ext>
              </a:extLst>
            </p:cNvPr>
            <p:cNvSpPr txBox="1"/>
            <p:nvPr/>
          </p:nvSpPr>
          <p:spPr>
            <a:xfrm>
              <a:off x="6070179" y="3930582"/>
              <a:ext cx="27991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Type of Cancer                                                       Incidence (95% CI)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EC2930B5-7C99-3D4C-9058-9A8AB3D37597}"/>
                </a:ext>
              </a:extLst>
            </p:cNvPr>
            <p:cNvSpPr txBox="1"/>
            <p:nvPr/>
          </p:nvSpPr>
          <p:spPr>
            <a:xfrm>
              <a:off x="3191980" y="3930582"/>
              <a:ext cx="27991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Type of Cancer                                                       Incidence (95% CI)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B30D06C8-D48E-DC4B-AC1F-2EE538BCB0A4}"/>
                </a:ext>
              </a:extLst>
            </p:cNvPr>
            <p:cNvSpPr txBox="1"/>
            <p:nvPr/>
          </p:nvSpPr>
          <p:spPr>
            <a:xfrm>
              <a:off x="167105" y="2023946"/>
              <a:ext cx="103410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00" dirty="0"/>
                <a:t>Primary liver cancer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EF9F2682-E7C4-FA4B-B2C3-0B7DD56547F1}"/>
                </a:ext>
              </a:extLst>
            </p:cNvPr>
            <p:cNvSpPr txBox="1"/>
            <p:nvPr/>
          </p:nvSpPr>
          <p:spPr>
            <a:xfrm>
              <a:off x="3083494" y="2046065"/>
              <a:ext cx="103410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00" dirty="0"/>
                <a:t>Primary liver cancer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7D1F3AE-335A-CC46-821D-6CD5A29BABCE}"/>
                </a:ext>
              </a:extLst>
            </p:cNvPr>
            <p:cNvSpPr txBox="1"/>
            <p:nvPr/>
          </p:nvSpPr>
          <p:spPr>
            <a:xfrm>
              <a:off x="184165" y="4886311"/>
              <a:ext cx="103410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00" dirty="0"/>
                <a:t>Primary liver cancer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FFA5C281-23C6-7643-A214-56F31E608F4D}"/>
                </a:ext>
              </a:extLst>
            </p:cNvPr>
            <p:cNvSpPr txBox="1"/>
            <p:nvPr/>
          </p:nvSpPr>
          <p:spPr>
            <a:xfrm>
              <a:off x="3084714" y="4904214"/>
              <a:ext cx="103410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00" dirty="0"/>
                <a:t>Primary liver cancer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C3ED558E-6337-8D4A-ABE3-CCCA23D36908}"/>
                </a:ext>
              </a:extLst>
            </p:cNvPr>
            <p:cNvSpPr txBox="1"/>
            <p:nvPr/>
          </p:nvSpPr>
          <p:spPr>
            <a:xfrm>
              <a:off x="5965125" y="2010194"/>
              <a:ext cx="103410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00" dirty="0"/>
                <a:t>Primary liver cancer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B4A99CCF-D79D-F642-8456-E4AD53229620}"/>
                </a:ext>
              </a:extLst>
            </p:cNvPr>
            <p:cNvSpPr txBox="1"/>
            <p:nvPr/>
          </p:nvSpPr>
          <p:spPr>
            <a:xfrm>
              <a:off x="8837567" y="2043448"/>
              <a:ext cx="103410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00" dirty="0"/>
                <a:t>Primary liver cancer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6C488B6A-1D36-2C42-B636-E92D9CAA936F}"/>
                </a:ext>
              </a:extLst>
            </p:cNvPr>
            <p:cNvSpPr txBox="1"/>
            <p:nvPr/>
          </p:nvSpPr>
          <p:spPr>
            <a:xfrm>
              <a:off x="6002773" y="4888099"/>
              <a:ext cx="103410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700" dirty="0"/>
                <a:t>Primary liver cancer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964545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3A23DD3-C7B8-4F41-9838-999DE0C794D2}"/>
              </a:ext>
            </a:extLst>
          </p:cNvPr>
          <p:cNvSpPr txBox="1"/>
          <p:nvPr/>
        </p:nvSpPr>
        <p:spPr>
          <a:xfrm>
            <a:off x="1137365" y="6188044"/>
            <a:ext cx="10323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ure S4 Incidence of </a:t>
            </a:r>
            <a:r>
              <a:rPr lang="en-US" b="1" dirty="0">
                <a:sym typeface="Symbol" pitchFamily="2" charset="2"/>
              </a:rPr>
              <a:t></a:t>
            </a:r>
            <a:r>
              <a:rPr lang="en-US" b="1" dirty="0">
                <a:effectLst/>
              </a:rPr>
              <a:t> Grade 3 </a:t>
            </a:r>
            <a:r>
              <a:rPr lang="en-US" b="1" dirty="0"/>
              <a:t>hepatotoxicity in primary live cancers vs. other cancer types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083534A-6B72-B644-A698-8CAC0B0FB66C}"/>
              </a:ext>
            </a:extLst>
          </p:cNvPr>
          <p:cNvSpPr txBox="1"/>
          <p:nvPr/>
        </p:nvSpPr>
        <p:spPr>
          <a:xfrm>
            <a:off x="151475" y="487684"/>
            <a:ext cx="4700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4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BC5D72B-11D4-BA49-873F-0CEE654B1D9E}"/>
              </a:ext>
            </a:extLst>
          </p:cNvPr>
          <p:cNvSpPr txBox="1"/>
          <p:nvPr/>
        </p:nvSpPr>
        <p:spPr>
          <a:xfrm>
            <a:off x="3088749" y="487684"/>
            <a:ext cx="4619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4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E8AA124-973C-EA48-9547-FD9495975D0A}"/>
              </a:ext>
            </a:extLst>
          </p:cNvPr>
          <p:cNvSpPr txBox="1"/>
          <p:nvPr/>
        </p:nvSpPr>
        <p:spPr>
          <a:xfrm>
            <a:off x="268491" y="1071479"/>
            <a:ext cx="27991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Type of Cancer                                                       Incidence (95% CI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E1C9D17-FF47-1047-BADC-3530CE7C1400}"/>
              </a:ext>
            </a:extLst>
          </p:cNvPr>
          <p:cNvSpPr txBox="1"/>
          <p:nvPr/>
        </p:nvSpPr>
        <p:spPr>
          <a:xfrm>
            <a:off x="3191980" y="1071479"/>
            <a:ext cx="27991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Type of Cancer                                                       Incidence (95% CI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A2DD440-2658-2148-8FFE-9D32CD633FD4}"/>
              </a:ext>
            </a:extLst>
          </p:cNvPr>
          <p:cNvSpPr txBox="1"/>
          <p:nvPr/>
        </p:nvSpPr>
        <p:spPr>
          <a:xfrm>
            <a:off x="6070179" y="1068029"/>
            <a:ext cx="27991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Type of Cancer                                                       Incidence (95% CI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87EA326-0B3D-A94C-ACC2-E524F65CFC86}"/>
              </a:ext>
            </a:extLst>
          </p:cNvPr>
          <p:cNvSpPr txBox="1"/>
          <p:nvPr/>
        </p:nvSpPr>
        <p:spPr>
          <a:xfrm>
            <a:off x="8944508" y="1068029"/>
            <a:ext cx="27991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Type of Cancer                                                       Incidence (95% CI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B38A539-4138-3D4E-B284-A424231DA72F}"/>
              </a:ext>
            </a:extLst>
          </p:cNvPr>
          <p:cNvSpPr txBox="1"/>
          <p:nvPr/>
        </p:nvSpPr>
        <p:spPr>
          <a:xfrm>
            <a:off x="5987143" y="500444"/>
            <a:ext cx="4555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4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20C5949-A6FC-EF45-8AD1-776CB0519DD9}"/>
              </a:ext>
            </a:extLst>
          </p:cNvPr>
          <p:cNvSpPr txBox="1"/>
          <p:nvPr/>
        </p:nvSpPr>
        <p:spPr>
          <a:xfrm>
            <a:off x="8916258" y="500444"/>
            <a:ext cx="4748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4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809C0BF-BF16-9C47-B1B4-3CC3939264E7}"/>
              </a:ext>
            </a:extLst>
          </p:cNvPr>
          <p:cNvSpPr txBox="1"/>
          <p:nvPr/>
        </p:nvSpPr>
        <p:spPr>
          <a:xfrm>
            <a:off x="151475" y="3312729"/>
            <a:ext cx="4491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4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04B4C72-749E-ED4F-A711-BD4C8FC10162}"/>
              </a:ext>
            </a:extLst>
          </p:cNvPr>
          <p:cNvSpPr txBox="1"/>
          <p:nvPr/>
        </p:nvSpPr>
        <p:spPr>
          <a:xfrm>
            <a:off x="3114754" y="3312729"/>
            <a:ext cx="4427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4F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DC651F3-EE72-CD48-A70D-5BD66DE245F5}"/>
              </a:ext>
            </a:extLst>
          </p:cNvPr>
          <p:cNvSpPr txBox="1"/>
          <p:nvPr/>
        </p:nvSpPr>
        <p:spPr>
          <a:xfrm>
            <a:off x="268491" y="3985012"/>
            <a:ext cx="27991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Type of Cancer                                                       Incidence (95% CI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D7587D9-15E9-7142-9008-207ECB65B478}"/>
              </a:ext>
            </a:extLst>
          </p:cNvPr>
          <p:cNvSpPr txBox="1"/>
          <p:nvPr/>
        </p:nvSpPr>
        <p:spPr>
          <a:xfrm>
            <a:off x="5987143" y="3312729"/>
            <a:ext cx="4748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4G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555AC96-A21D-844C-A8E6-DE2F8FAD979D}"/>
              </a:ext>
            </a:extLst>
          </p:cNvPr>
          <p:cNvSpPr txBox="1"/>
          <p:nvPr/>
        </p:nvSpPr>
        <p:spPr>
          <a:xfrm>
            <a:off x="6070179" y="3985012"/>
            <a:ext cx="27991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Type of Cancer                                                       Incidence (95% CI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0377F72-3FFB-A945-A2F1-F74126BD5788}"/>
              </a:ext>
            </a:extLst>
          </p:cNvPr>
          <p:cNvSpPr txBox="1"/>
          <p:nvPr/>
        </p:nvSpPr>
        <p:spPr>
          <a:xfrm>
            <a:off x="3191980" y="3985012"/>
            <a:ext cx="27991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Type of Cancer                                                       Incidence (95% CI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AFA5A1D-B3AC-8D4D-B922-78DCC975D32E}"/>
              </a:ext>
            </a:extLst>
          </p:cNvPr>
          <p:cNvSpPr txBox="1"/>
          <p:nvPr/>
        </p:nvSpPr>
        <p:spPr>
          <a:xfrm>
            <a:off x="1328897" y="818178"/>
            <a:ext cx="4440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LT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F9B30D0-92DA-F74F-BE40-79CFDFE379E4}"/>
              </a:ext>
            </a:extLst>
          </p:cNvPr>
          <p:cNvSpPr txBox="1"/>
          <p:nvPr/>
        </p:nvSpPr>
        <p:spPr>
          <a:xfrm>
            <a:off x="4182963" y="818178"/>
            <a:ext cx="4650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ST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1DBF940-0028-874D-B662-2FA82FE19345}"/>
              </a:ext>
            </a:extLst>
          </p:cNvPr>
          <p:cNvSpPr txBox="1"/>
          <p:nvPr/>
        </p:nvSpPr>
        <p:spPr>
          <a:xfrm>
            <a:off x="6900783" y="818178"/>
            <a:ext cx="8178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ilirubin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CEA6AD0-5573-4949-87A3-3DBEF82846C6}"/>
              </a:ext>
            </a:extLst>
          </p:cNvPr>
          <p:cNvSpPr txBox="1"/>
          <p:nvPr/>
        </p:nvSpPr>
        <p:spPr>
          <a:xfrm>
            <a:off x="9930606" y="818178"/>
            <a:ext cx="4651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LP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B5B78E9-2CBA-214B-9570-64EBC5F434D1}"/>
              </a:ext>
            </a:extLst>
          </p:cNvPr>
          <p:cNvSpPr txBox="1"/>
          <p:nvPr/>
        </p:nvSpPr>
        <p:spPr>
          <a:xfrm>
            <a:off x="1185583" y="3682082"/>
            <a:ext cx="4995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GGT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7441005-1BED-874A-A77B-D39A43D3AFC9}"/>
              </a:ext>
            </a:extLst>
          </p:cNvPr>
          <p:cNvSpPr txBox="1"/>
          <p:nvPr/>
        </p:nvSpPr>
        <p:spPr>
          <a:xfrm>
            <a:off x="3682096" y="3682082"/>
            <a:ext cx="20051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Nonspecific liver toxicity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03EB76F-C43A-014D-860E-9AFBA3F176A8}"/>
              </a:ext>
            </a:extLst>
          </p:cNvPr>
          <p:cNvSpPr txBox="1"/>
          <p:nvPr/>
        </p:nvSpPr>
        <p:spPr>
          <a:xfrm>
            <a:off x="6808001" y="3682082"/>
            <a:ext cx="10034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/>
              <a:t>Ir</a:t>
            </a:r>
            <a:r>
              <a:rPr lang="en-US" sz="1400" b="1" dirty="0"/>
              <a:t>-hepatitis</a:t>
            </a:r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459FE40E-C5DB-4145-B196-387A014269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3168" y="1338946"/>
            <a:ext cx="2611952" cy="1807535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509E3670-9E81-2A4E-ACC3-914D499ACD3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91980" y="1325116"/>
            <a:ext cx="2631475" cy="1831998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9E4C0AAF-7A5C-0E45-9BC3-C1703D1F9A9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74562" y="1334894"/>
            <a:ext cx="2617601" cy="1831998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AD7ECD41-6456-0A4A-8BFB-33E0F306659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966422" y="1334894"/>
            <a:ext cx="2585208" cy="1797577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0561148D-5341-EB46-AE0D-F24E948BD9F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7225" y="4268035"/>
            <a:ext cx="2639638" cy="1836410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0C8FFCB7-6382-6F4B-8686-7644DCCF540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72894" y="4260009"/>
            <a:ext cx="2641455" cy="183641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F725EA4C-78AC-5E40-8FCE-459BE6C01A1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060518" y="4240486"/>
            <a:ext cx="2661864" cy="1863959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3574FF43-7FF5-B644-B476-72AF9FC35E62}"/>
              </a:ext>
            </a:extLst>
          </p:cNvPr>
          <p:cNvSpPr txBox="1"/>
          <p:nvPr/>
        </p:nvSpPr>
        <p:spPr>
          <a:xfrm>
            <a:off x="198365" y="2023946"/>
            <a:ext cx="1034108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700" dirty="0"/>
              <a:t>Primary liver cancer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177EC56-06B2-0543-B610-CB4CB55AE0DA}"/>
              </a:ext>
            </a:extLst>
          </p:cNvPr>
          <p:cNvSpPr txBox="1"/>
          <p:nvPr/>
        </p:nvSpPr>
        <p:spPr>
          <a:xfrm>
            <a:off x="3114754" y="2030435"/>
            <a:ext cx="1034108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700" dirty="0"/>
              <a:t>Primary liver cancer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A68C648-C6A5-8B45-8020-5BBDAC75A9AD}"/>
              </a:ext>
            </a:extLst>
          </p:cNvPr>
          <p:cNvSpPr txBox="1"/>
          <p:nvPr/>
        </p:nvSpPr>
        <p:spPr>
          <a:xfrm>
            <a:off x="176350" y="4987906"/>
            <a:ext cx="1034108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700" dirty="0"/>
              <a:t>Primary liver cancer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D0B4A05-FA35-A545-8B3D-C544A3AED87E}"/>
              </a:ext>
            </a:extLst>
          </p:cNvPr>
          <p:cNvSpPr txBox="1"/>
          <p:nvPr/>
        </p:nvSpPr>
        <p:spPr>
          <a:xfrm>
            <a:off x="3100344" y="4982364"/>
            <a:ext cx="1034108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700" dirty="0"/>
              <a:t>Primary liver cancer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6160612-C58A-D348-9C92-92DB10CFC78F}"/>
              </a:ext>
            </a:extLst>
          </p:cNvPr>
          <p:cNvSpPr txBox="1"/>
          <p:nvPr/>
        </p:nvSpPr>
        <p:spPr>
          <a:xfrm>
            <a:off x="5996385" y="2041454"/>
            <a:ext cx="1034108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700" dirty="0"/>
              <a:t>Primary liver cancer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E54D541-2063-634F-A4BF-54F1EAB5AC09}"/>
              </a:ext>
            </a:extLst>
          </p:cNvPr>
          <p:cNvSpPr txBox="1"/>
          <p:nvPr/>
        </p:nvSpPr>
        <p:spPr>
          <a:xfrm>
            <a:off x="8892272" y="2035633"/>
            <a:ext cx="1034108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700" dirty="0"/>
              <a:t>Primary liver cancer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747A845-D42B-5943-A41D-7B959E6BC06C}"/>
              </a:ext>
            </a:extLst>
          </p:cNvPr>
          <p:cNvSpPr txBox="1"/>
          <p:nvPr/>
        </p:nvSpPr>
        <p:spPr>
          <a:xfrm>
            <a:off x="5994958" y="4966249"/>
            <a:ext cx="1034108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700" dirty="0"/>
              <a:t>Primary liver cancer</a:t>
            </a:r>
          </a:p>
        </p:txBody>
      </p:sp>
    </p:spTree>
    <p:extLst>
      <p:ext uri="{BB962C8B-B14F-4D97-AF65-F5344CB8AC3E}">
        <p14:creationId xmlns:p14="http://schemas.microsoft.com/office/powerpoint/2010/main" val="19197779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3</TotalTime>
  <Words>256</Words>
  <Application>Microsoft Macintosh PowerPoint</Application>
  <PresentationFormat>Widescreen</PresentationFormat>
  <Paragraphs>6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e, Changqing (NIH/NCI) [E]</dc:creator>
  <cp:lastModifiedBy>Xie, Changqing (NIH/NCI) [E]</cp:lastModifiedBy>
  <cp:revision>12</cp:revision>
  <dcterms:created xsi:type="dcterms:W3CDTF">2020-08-29T12:44:42Z</dcterms:created>
  <dcterms:modified xsi:type="dcterms:W3CDTF">2020-10-07T20:27:28Z</dcterms:modified>
</cp:coreProperties>
</file>